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0" r:id="rId2"/>
    <p:sldId id="273" r:id="rId3"/>
    <p:sldId id="274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DHC20" initials="M" lastIdx="1" clrIdx="0">
    <p:extLst>
      <p:ext uri="{19B8F6BF-5375-455C-9EA6-DF929625EA0E}">
        <p15:presenceInfo xmlns:p15="http://schemas.microsoft.com/office/powerpoint/2012/main" userId="MDHC20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0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FECB4D8-DB02-4DC6-A0A2-4F2EBAE1DC90}" styleName="보통 스타일 1 - 강조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보통 스타일 3 - 강조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7412" autoAdjust="0"/>
  </p:normalViewPr>
  <p:slideViewPr>
    <p:cSldViewPr snapToGrid="0">
      <p:cViewPr varScale="1">
        <p:scale>
          <a:sx n="97" d="100"/>
          <a:sy n="97" d="100"/>
        </p:scale>
        <p:origin x="9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025573-DEF1-4611-B0FE-A66472D22AF7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59484A-8BC4-4D78-BDC2-CFC84F3C8A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653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</a:t>
            </a: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pha diversity of microbiome defined by various indices in 4 sample types.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bserved, Chao1, Shannon, and Simpson indices between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control group and the gastric cancer group are shown</a:t>
            </a:r>
            <a:r>
              <a:rPr lang="en-US" altLang="ko-KR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ool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cteria (ST-Bac) isolated from stool pellet,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ool-derived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tracellular vesicle (ST-EV) isolated from stool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ernatant,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rine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rum.</a:t>
            </a:r>
            <a:endParaRPr lang="ko-KR" altLang="en-US" b="1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59484A-8BC4-4D78-BDC2-CFC84F3C8A7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81377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anges in the relative abundances of individual phyla in gastric cancer in 4 sample types.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yla showing significant changes are shown with error bars indicating standard error 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</a:t>
            </a: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ool bacteria (ST-Bac) isolated from stool pellet, 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</a:t>
            </a: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ool-derived extracellular vesicle (ST-EV) isolated from stool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ernatant,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</a:t>
            </a: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rine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rum</a:t>
            </a:r>
            <a:r>
              <a:rPr lang="en-US" altLang="ko-KR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gnificance </a:t>
            </a:r>
            <a:r>
              <a:rPr lang="en-US" altLang="ko-KR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groups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e</a:t>
            </a:r>
            <a:r>
              <a:rPr lang="en-US" altLang="ko-KR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aluated with</a:t>
            </a:r>
            <a:r>
              <a:rPr lang="en-US" altLang="ko-KR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-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st</a:t>
            </a:r>
            <a:r>
              <a:rPr lang="en-US" altLang="ko-KR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*p </a:t>
            </a:r>
            <a:r>
              <a:rPr lang="en-US" altLang="ko-KR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 0.05, 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*p </a:t>
            </a:r>
            <a:r>
              <a:rPr lang="en-US" altLang="ko-KR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 0.01</a:t>
            </a:r>
            <a:r>
              <a:rPr lang="en-US" altLang="ko-KR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endParaRPr lang="ko-KR" altLang="en-US" b="0" dirty="0"/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dirty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59484A-8BC4-4D78-BDC2-CFC84F3C8A7B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4364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. Comparison of gastric cancer diagnostic prediction models between healthy controls and EGC or AGC in 4 sample types.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erformance indices of each model are demonstrated: (A) EGC vs. control, stool bacteria (ST-Bac) isolated from stool pellet, (B) EGC vs. control, stool-derived extracellular vesicle (ST-EV) isolated from stool supernatant, (C) EGC vs. control, urine, and (D) EGC vs. control, serum, (E) AGC vs. control, ST-Bac,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F)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C vs. control, ST-EV,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G)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C vs. control, urine, and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H) 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GC vs. control, serum. EGC, early gastric cancer; AGC, advanced gastric cancer; AUC, area under the curve; SEN, sensitivity; SPE, specificity; ACC, accuracy.</a:t>
            </a:r>
            <a:endParaRPr lang="ko-KR" altLang="en-US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59484A-8BC4-4D78-BDC2-CFC84F3C8A7B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6555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EFD9A47-E76D-4394-8A22-B529B3A483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5A9604D-2A36-4E91-B3CB-20CFEDC5AF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385CD0-2F9E-4554-BDB1-510DDCB64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D2EE6AF-D9F8-45E5-87CE-DBD5DE724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8ABE35-1010-43E6-A982-1DCCFBB1A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8002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3C36BD-4A66-4B85-8F15-9C09D03C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BA87A7B-F958-4A64-BC02-EE5EEC0913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34EB0D1-4C1D-4D14-9555-7AAE566F1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13B37EB-2FF7-44B0-A0E9-2AD69F10A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FA558E5-6AFA-4BBE-A51B-1F2D7F344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330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B36A442-F0C8-4438-877C-ABDCEF34EC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D69DE0E-78F2-495A-80DE-AD4621C12A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AF1FE89-02C2-4A58-B73C-B5FE50E3E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FD9E31-566F-4F56-B28D-46C20FD62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0484BD3-21C2-4A24-B9B1-55852CD62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5395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7DD7A1F-8DB7-4556-AF8E-FCBFD59933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B558D1E-CB66-4267-91DE-3A94BFC01D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4F4A63A-8C73-4825-9B04-638C32928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995ED3-FECD-4FE3-9B65-01AC79DC9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AE84F1-C82F-4EC3-ADFD-96E79A727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1594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907BD38-A2BF-457B-A649-11AB08D0EBF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ko-KR" dirty="0"/>
              <a:t>Master</a:t>
            </a:r>
            <a:endParaRPr lang="ko-KR" altLang="en-US" dirty="0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7941D14-C81E-452C-8B61-3658278CA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FAA8BD0-D40B-4628-B87E-83BCB7FB4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B4E4648-9FE3-4A55-ACF3-B00DEBFB1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A0E8C5A-8711-4157-859B-08D55C0B1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1039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243F64-2F1B-4ABD-8A09-A47C0FE09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E83E289-DA49-4511-B06F-E949236D21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2362243-0B19-4F28-AA4F-2D36B41D58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931C51E-2D7E-4C2E-8934-F68B3A0F6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53C5BD7-D334-4C63-AB62-6C8C1B31E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6F703C3-83EA-41AD-BE6B-01518D150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3937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EAAF70-DEA4-47BD-B2F4-813361B01A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3F1D57B-E4A6-40B5-8379-3E5471333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934B2F3-C319-4396-A195-40F2BEE96E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DEBC38B-3B6B-4517-8C44-F6788C85AA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59DCD11-66C0-45C8-A5C8-A1BD1376A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075BAA3-D724-4E10-89CF-C347063E9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594ED9E-39A6-4391-80AE-E20507B41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64ABB43-4DE6-4B32-B38C-83B0F0FBF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5934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BEC088-2994-47E9-8411-7F92FEFB3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1C9A23E-E4E0-43D2-A263-8CC6AD0F5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7652CB8-E5A7-4641-89B9-06D161D84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4D82008-16DE-41B5-BE9E-04820D349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231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3623631-2742-4B88-8E17-5BBE5EFE3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D4DA06D-7829-41A5-810F-460C7E8B9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15F9030-2513-4553-89A9-A892D3FCD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980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41FAA5-5816-4C86-8030-02D5CCA12E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FD78359-E1BD-4E7B-8AAC-026206CE14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90E25D6-24F4-4D01-ADD7-98FD260FD6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8A66EFE-74F1-4182-A72B-26ACCE4CB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12A1AC2-4AFF-4D2F-A211-B1D4EBB0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91541BE-F27B-413E-BE6A-D674B3EBB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342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6B6A4B-90C3-4AB9-AAD9-F24AE1613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5A5CC4B-E439-4344-B1E5-44FBF7F6F2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8C72557-2D09-4533-B829-3DBF468C77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88A045F-5941-4285-A111-58489984A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5D87E-B6E0-44E6-9BFD-4F4139B06A3A}" type="datetimeFigureOut">
              <a:rPr lang="ko-KR" altLang="en-US" smtClean="0"/>
              <a:t>2021-09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C0D7E14-676E-4E25-A5B0-4371408CB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08A3819-542E-4C32-B2DA-A909F63AD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73A01-48B8-460B-BDEF-894446C2C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4221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47D20E4-CC65-47DA-8283-90EE2B129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84361F-E8C1-47CF-9B61-CCCEA655D0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14696A-2CCD-4A7E-B412-D6E2123913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BC85D87E-B6E0-44E6-9BFD-4F4139B06A3A}" type="datetimeFigureOut">
              <a:rPr lang="ko-KR" altLang="en-US" smtClean="0"/>
              <a:pPr/>
              <a:t>2021-09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00116A-91FF-4AA7-9AF1-5D47F04343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A4BC12-7A14-423F-91A3-B0083827F9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fld id="{FC673A01-48B8-460B-BDEF-894446C2CBA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7477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Times New Roman" panose="02020603050405020304" pitchFamily="18" charset="0"/>
          <a:ea typeface="+mj-ea"/>
          <a:cs typeface="Times New Roman" panose="02020603050405020304" pitchFamily="18" charset="0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>
            <a:extLst>
              <a:ext uri="{FF2B5EF4-FFF2-40B4-BE49-F238E27FC236}">
                <a16:creationId xmlns:a16="http://schemas.microsoft.com/office/drawing/2014/main" id="{11ACB8DB-AF10-4794-9E81-B82F6E0D1B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92"/>
          <a:stretch/>
        </p:blipFill>
        <p:spPr>
          <a:xfrm>
            <a:off x="6270074" y="334772"/>
            <a:ext cx="3495211" cy="3099636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4A1B54E0-D4CB-4B58-AF91-6A743BB7420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66"/>
          <a:stretch/>
        </p:blipFill>
        <p:spPr>
          <a:xfrm>
            <a:off x="2247908" y="334772"/>
            <a:ext cx="3496288" cy="3099636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562608B9-C25B-4522-B17B-FCA905E6701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66"/>
          <a:stretch/>
        </p:blipFill>
        <p:spPr>
          <a:xfrm>
            <a:off x="2247908" y="3595619"/>
            <a:ext cx="3496288" cy="3099635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48B0423E-255F-44F2-968B-37EA31CC912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75"/>
          <a:stretch/>
        </p:blipFill>
        <p:spPr>
          <a:xfrm>
            <a:off x="6254764" y="3595620"/>
            <a:ext cx="3510521" cy="3112578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ACF5FEC6-E64E-4DCA-A965-7126A1C6CC5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66" t="40965" r="-607" b="45974"/>
          <a:stretch/>
        </p:blipFill>
        <p:spPr>
          <a:xfrm>
            <a:off x="10089003" y="2981963"/>
            <a:ext cx="1606722" cy="9442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2023306" y="177395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6059500" y="177394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2023306" y="3595619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6059500" y="3566123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3637301" y="6411633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in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7767716" y="3146295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EV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3676644" y="3146295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Ba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7767716" y="6421464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312155" y="164989"/>
            <a:ext cx="1299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1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00625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그림 34">
            <a:extLst>
              <a:ext uri="{FF2B5EF4-FFF2-40B4-BE49-F238E27FC236}">
                <a16:creationId xmlns:a16="http://schemas.microsoft.com/office/drawing/2014/main" id="{159251A2-356C-4A82-90E0-3991EF608CD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462"/>
          <a:stretch/>
        </p:blipFill>
        <p:spPr>
          <a:xfrm>
            <a:off x="6186876" y="1843009"/>
            <a:ext cx="2695324" cy="3600000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C612CC54-8A2D-496A-901D-D8DAF41B087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172"/>
          <a:stretch/>
        </p:blipFill>
        <p:spPr>
          <a:xfrm>
            <a:off x="8997998" y="1843009"/>
            <a:ext cx="3027787" cy="3600000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08A5ECDC-65A0-4E33-896F-3E9795FB755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881"/>
          <a:stretch/>
        </p:blipFill>
        <p:spPr>
          <a:xfrm>
            <a:off x="3468367" y="1843009"/>
            <a:ext cx="2567783" cy="360000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35FE6525-380E-421F-AAA2-4EDD7A40AC3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287"/>
          <a:stretch/>
        </p:blipFill>
        <p:spPr>
          <a:xfrm>
            <a:off x="541901" y="1843009"/>
            <a:ext cx="2552700" cy="3600000"/>
          </a:xfrm>
          <a:prstGeom prst="rect">
            <a:avLst/>
          </a:prstGeom>
        </p:spPr>
      </p:pic>
      <p:sp>
        <p:nvSpPr>
          <p:cNvPr id="16" name="직사각형 15"/>
          <p:cNvSpPr/>
          <p:nvPr/>
        </p:nvSpPr>
        <p:spPr>
          <a:xfrm>
            <a:off x="312155" y="164989"/>
            <a:ext cx="1299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2 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7247343" y="5268582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in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4411103" y="5268582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EV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1481739" y="5269152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Ba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10093393" y="5268582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그룹 31"/>
          <p:cNvGrpSpPr/>
          <p:nvPr/>
        </p:nvGrpSpPr>
        <p:grpSpPr>
          <a:xfrm>
            <a:off x="5479046" y="5814670"/>
            <a:ext cx="1505604" cy="515206"/>
            <a:chOff x="3902510" y="1263851"/>
            <a:chExt cx="1505604" cy="515206"/>
          </a:xfrm>
        </p:grpSpPr>
        <p:sp>
          <p:nvSpPr>
            <p:cNvPr id="33" name="TextBox 32"/>
            <p:cNvSpPr txBox="1"/>
            <p:nvPr/>
          </p:nvSpPr>
          <p:spPr>
            <a:xfrm>
              <a:off x="4157451" y="1263851"/>
              <a:ext cx="1250663" cy="51520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pPr>
                <a:lnSpc>
                  <a:spcPct val="120000"/>
                </a:lnSpc>
              </a:pP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stric cancer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그림 3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02510" y="1283568"/>
              <a:ext cx="293155" cy="469049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434638" y="1459765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3413117" y="1459763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6142825" y="1459763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8939208" y="1459763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5163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287153" y="485138"/>
            <a:ext cx="11767195" cy="285527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48" name="그림 47">
            <a:extLst>
              <a:ext uri="{FF2B5EF4-FFF2-40B4-BE49-F238E27FC236}">
                <a16:creationId xmlns:a16="http://schemas.microsoft.com/office/drawing/2014/main" id="{3BE3265C-5436-4391-B2BE-36A6415E6B1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4" t="7504" b="12301"/>
          <a:stretch/>
        </p:blipFill>
        <p:spPr>
          <a:xfrm>
            <a:off x="816078" y="766918"/>
            <a:ext cx="2450468" cy="1573161"/>
          </a:xfrm>
          <a:prstGeom prst="rect">
            <a:avLst/>
          </a:prstGeom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4C2D4CED-9674-459C-90E0-8DD5973C2A1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3" t="9838" b="12873"/>
          <a:stretch/>
        </p:blipFill>
        <p:spPr>
          <a:xfrm>
            <a:off x="806246" y="4162394"/>
            <a:ext cx="2450468" cy="1524663"/>
          </a:xfrm>
          <a:prstGeom prst="rect">
            <a:avLst/>
          </a:prstGeom>
        </p:spPr>
      </p:pic>
      <p:pic>
        <p:nvPicPr>
          <p:cNvPr id="50" name="그림 49">
            <a:extLst>
              <a:ext uri="{FF2B5EF4-FFF2-40B4-BE49-F238E27FC236}">
                <a16:creationId xmlns:a16="http://schemas.microsoft.com/office/drawing/2014/main" id="{CE54075A-F3D9-49EA-859B-426099D059E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6" t="7279" b="12827"/>
          <a:stretch/>
        </p:blipFill>
        <p:spPr>
          <a:xfrm>
            <a:off x="3681194" y="4106458"/>
            <a:ext cx="2462579" cy="1585253"/>
          </a:xfrm>
          <a:prstGeom prst="rect">
            <a:avLst/>
          </a:prstGeom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425B94E2-7222-4748-912E-2E9ACE0807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9" t="8437" b="12546"/>
          <a:stretch/>
        </p:blipFill>
        <p:spPr>
          <a:xfrm>
            <a:off x="3679493" y="798178"/>
            <a:ext cx="2454472" cy="1561565"/>
          </a:xfrm>
          <a:prstGeom prst="rect">
            <a:avLst/>
          </a:prstGeom>
        </p:spPr>
      </p:pic>
      <p:pic>
        <p:nvPicPr>
          <p:cNvPr id="52" name="그림 51">
            <a:extLst>
              <a:ext uri="{FF2B5EF4-FFF2-40B4-BE49-F238E27FC236}">
                <a16:creationId xmlns:a16="http://schemas.microsoft.com/office/drawing/2014/main" id="{E00A2269-632F-477C-8393-3B7470C31E7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0" t="8991" b="12589"/>
          <a:stretch/>
        </p:blipFill>
        <p:spPr>
          <a:xfrm>
            <a:off x="6582573" y="4128078"/>
            <a:ext cx="2466837" cy="1593294"/>
          </a:xfrm>
          <a:prstGeom prst="rect">
            <a:avLst/>
          </a:prstGeom>
        </p:spPr>
      </p:pic>
      <p:pic>
        <p:nvPicPr>
          <p:cNvPr id="53" name="그림 52">
            <a:extLst>
              <a:ext uri="{FF2B5EF4-FFF2-40B4-BE49-F238E27FC236}">
                <a16:creationId xmlns:a16="http://schemas.microsoft.com/office/drawing/2014/main" id="{2EA4D36B-9D12-41DF-A404-7E98A4A8D69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1" t="9352" b="12893"/>
          <a:stretch/>
        </p:blipFill>
        <p:spPr>
          <a:xfrm>
            <a:off x="6582573" y="816079"/>
            <a:ext cx="2457982" cy="1537202"/>
          </a:xfrm>
          <a:prstGeom prst="rect">
            <a:avLst/>
          </a:prstGeom>
        </p:spPr>
      </p:pic>
      <p:pic>
        <p:nvPicPr>
          <p:cNvPr id="54" name="그림 53">
            <a:extLst>
              <a:ext uri="{FF2B5EF4-FFF2-40B4-BE49-F238E27FC236}">
                <a16:creationId xmlns:a16="http://schemas.microsoft.com/office/drawing/2014/main" id="{EADF713F-B806-4858-8CF7-2E4F8C5DA90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3" t="8755" b="12536"/>
          <a:stretch/>
        </p:blipFill>
        <p:spPr>
          <a:xfrm>
            <a:off x="9478298" y="784868"/>
            <a:ext cx="2488150" cy="1571608"/>
          </a:xfrm>
          <a:prstGeom prst="rect">
            <a:avLst/>
          </a:prstGeom>
        </p:spPr>
      </p:pic>
      <p:pic>
        <p:nvPicPr>
          <p:cNvPr id="55" name="그림 54">
            <a:extLst>
              <a:ext uri="{FF2B5EF4-FFF2-40B4-BE49-F238E27FC236}">
                <a16:creationId xmlns:a16="http://schemas.microsoft.com/office/drawing/2014/main" id="{066C10BD-C938-45A2-BB61-EC4EF62FDB5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3" t="9296" b="13078"/>
          <a:stretch/>
        </p:blipFill>
        <p:spPr>
          <a:xfrm>
            <a:off x="9447770" y="4128078"/>
            <a:ext cx="2518678" cy="1574824"/>
          </a:xfrm>
          <a:prstGeom prst="rect">
            <a:avLst/>
          </a:prstGeom>
        </p:spPr>
      </p:pic>
      <p:graphicFrame>
        <p:nvGraphicFramePr>
          <p:cNvPr id="42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4277495"/>
              </p:ext>
            </p:extLst>
          </p:nvPr>
        </p:nvGraphicFramePr>
        <p:xfrm>
          <a:off x="743718" y="2722584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0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1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5635964" y="140670"/>
            <a:ext cx="1704636" cy="3385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GC vs control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461922" y="806247"/>
            <a:ext cx="2709971" cy="1835589"/>
            <a:chOff x="501250" y="884903"/>
            <a:chExt cx="2709971" cy="1835589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직사각형 15"/>
          <p:cNvSpPr/>
          <p:nvPr/>
        </p:nvSpPr>
        <p:spPr>
          <a:xfrm>
            <a:off x="312155" y="86333"/>
            <a:ext cx="1299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3 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7376961" y="3872596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in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4540721" y="3882428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EV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1611357" y="3882998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Ba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10223011" y="3872596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5555558" y="3492711"/>
            <a:ext cx="1704636" cy="3385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C vs control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1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3489624"/>
              </p:ext>
            </p:extLst>
          </p:nvPr>
        </p:nvGraphicFramePr>
        <p:xfrm>
          <a:off x="757390" y="6087607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4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4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aphicFrame>
        <p:nvGraphicFramePr>
          <p:cNvPr id="62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877274"/>
              </p:ext>
            </p:extLst>
          </p:nvPr>
        </p:nvGraphicFramePr>
        <p:xfrm>
          <a:off x="9537289" y="2730220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0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2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aphicFrame>
        <p:nvGraphicFramePr>
          <p:cNvPr id="63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167379"/>
              </p:ext>
            </p:extLst>
          </p:nvPr>
        </p:nvGraphicFramePr>
        <p:xfrm>
          <a:off x="3677265" y="2722584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5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aphicFrame>
        <p:nvGraphicFramePr>
          <p:cNvPr id="64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8453269"/>
              </p:ext>
            </p:extLst>
          </p:nvPr>
        </p:nvGraphicFramePr>
        <p:xfrm>
          <a:off x="6607277" y="2730220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3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0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2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aphicFrame>
        <p:nvGraphicFramePr>
          <p:cNvPr id="65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0193416"/>
              </p:ext>
            </p:extLst>
          </p:nvPr>
        </p:nvGraphicFramePr>
        <p:xfrm>
          <a:off x="3723861" y="6087607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8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pSp>
        <p:nvGrpSpPr>
          <p:cNvPr id="66" name="그룹 65"/>
          <p:cNvGrpSpPr/>
          <p:nvPr/>
        </p:nvGrpSpPr>
        <p:grpSpPr>
          <a:xfrm>
            <a:off x="453659" y="4157574"/>
            <a:ext cx="2709971" cy="1835589"/>
            <a:chOff x="501250" y="884903"/>
            <a:chExt cx="2709971" cy="1835589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그룹 71"/>
          <p:cNvGrpSpPr/>
          <p:nvPr/>
        </p:nvGrpSpPr>
        <p:grpSpPr>
          <a:xfrm>
            <a:off x="6219428" y="4177238"/>
            <a:ext cx="2709971" cy="1835589"/>
            <a:chOff x="501250" y="884903"/>
            <a:chExt cx="2709971" cy="1835589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7" name="그룹 76"/>
          <p:cNvGrpSpPr/>
          <p:nvPr/>
        </p:nvGrpSpPr>
        <p:grpSpPr>
          <a:xfrm>
            <a:off x="3321776" y="4157574"/>
            <a:ext cx="2709971" cy="1835589"/>
            <a:chOff x="501250" y="884903"/>
            <a:chExt cx="2709971" cy="1835589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2" name="그룹 81"/>
          <p:cNvGrpSpPr/>
          <p:nvPr/>
        </p:nvGrpSpPr>
        <p:grpSpPr>
          <a:xfrm>
            <a:off x="9115788" y="4159016"/>
            <a:ext cx="2709971" cy="1835589"/>
            <a:chOff x="501250" y="884903"/>
            <a:chExt cx="2709971" cy="1835589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그룹 86"/>
          <p:cNvGrpSpPr/>
          <p:nvPr/>
        </p:nvGrpSpPr>
        <p:grpSpPr>
          <a:xfrm>
            <a:off x="3339021" y="806247"/>
            <a:ext cx="2709971" cy="1835589"/>
            <a:chOff x="501250" y="884903"/>
            <a:chExt cx="2709971" cy="1835589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92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018713"/>
              </p:ext>
            </p:extLst>
          </p:nvPr>
        </p:nvGraphicFramePr>
        <p:xfrm>
          <a:off x="6578283" y="6087607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5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9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2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aphicFrame>
        <p:nvGraphicFramePr>
          <p:cNvPr id="93" name="표 2">
            <a:extLst>
              <a:ext uri="{FF2B5EF4-FFF2-40B4-BE49-F238E27FC236}">
                <a16:creationId xmlns:a16="http://schemas.microsoft.com/office/drawing/2014/main" id="{6C24D89C-3439-460B-86B9-2363104DB6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3584592"/>
              </p:ext>
            </p:extLst>
          </p:nvPr>
        </p:nvGraphicFramePr>
        <p:xfrm>
          <a:off x="9478298" y="6087607"/>
          <a:ext cx="2419912" cy="51816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4978">
                  <a:extLst>
                    <a:ext uri="{9D8B030D-6E8A-4147-A177-3AD203B41FA5}">
                      <a16:colId xmlns:a16="http://schemas.microsoft.com/office/drawing/2014/main" val="1747135996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1122510757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79739242"/>
                    </a:ext>
                  </a:extLst>
                </a:gridCol>
                <a:gridCol w="604978">
                  <a:extLst>
                    <a:ext uri="{9D8B030D-6E8A-4147-A177-3AD203B41FA5}">
                      <a16:colId xmlns:a16="http://schemas.microsoft.com/office/drawing/2014/main" val="36273249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1985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7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4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0</a:t>
                      </a:r>
                      <a:endParaRPr lang="ko-KR" alt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464717"/>
                  </a:ext>
                </a:extLst>
              </a:tr>
            </a:tbl>
          </a:graphicData>
        </a:graphic>
      </p:graphicFrame>
      <p:grpSp>
        <p:nvGrpSpPr>
          <p:cNvPr id="94" name="그룹 93"/>
          <p:cNvGrpSpPr/>
          <p:nvPr/>
        </p:nvGrpSpPr>
        <p:grpSpPr>
          <a:xfrm>
            <a:off x="6216540" y="821646"/>
            <a:ext cx="2709971" cy="1835589"/>
            <a:chOff x="501250" y="884903"/>
            <a:chExt cx="2709971" cy="1835589"/>
          </a:xfrm>
        </p:grpSpPr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그룹 98"/>
          <p:cNvGrpSpPr/>
          <p:nvPr/>
        </p:nvGrpSpPr>
        <p:grpSpPr>
          <a:xfrm>
            <a:off x="9127672" y="806247"/>
            <a:ext cx="2709971" cy="1835589"/>
            <a:chOff x="501250" y="884903"/>
            <a:chExt cx="2709971" cy="1835589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1425010" y="2545641"/>
              <a:ext cx="1264920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als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-145851" y="1574227"/>
              <a:ext cx="1469054" cy="1748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18000" bIns="18000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ue positive rate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>
              <a:off x="903720" y="2427541"/>
              <a:ext cx="230750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0.2          0.4         0.6          0.8          1.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2D97CFB-E9CC-423F-8BA5-CE1BFD737467}"/>
                </a:ext>
              </a:extLst>
            </p:cNvPr>
            <p:cNvSpPr txBox="1"/>
            <p:nvPr/>
          </p:nvSpPr>
          <p:spPr>
            <a:xfrm rot="16200000">
              <a:off x="8567" y="1587773"/>
              <a:ext cx="152885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spc="1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0    0.2    0.4    0.6    0.8    1.0</a:t>
              </a:r>
              <a:endParaRPr lang="ko-KR" altLang="en-US" sz="800" b="1" spc="1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287153" y="465552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3363952" y="465550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8998195" y="465550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6231308" y="465550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287153" y="3794667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3363952" y="3794665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8998195" y="3794665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6580AAA-E01A-4613-B81F-423B8E6149A0}"/>
              </a:ext>
            </a:extLst>
          </p:cNvPr>
          <p:cNvSpPr txBox="1"/>
          <p:nvPr/>
        </p:nvSpPr>
        <p:spPr>
          <a:xfrm>
            <a:off x="6231308" y="3794665"/>
            <a:ext cx="359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7376961" y="545525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in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4540721" y="545525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EV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2D97CFB-E9CC-423F-8BA5-CE1BFD737467}"/>
              </a:ext>
            </a:extLst>
          </p:cNvPr>
          <p:cNvSpPr txBox="1"/>
          <p:nvPr/>
        </p:nvSpPr>
        <p:spPr>
          <a:xfrm>
            <a:off x="1611357" y="546095"/>
            <a:ext cx="829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-Ba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5911522-B571-4BCA-A817-50116C1C9AAA}"/>
              </a:ext>
            </a:extLst>
          </p:cNvPr>
          <p:cNvSpPr txBox="1"/>
          <p:nvPr/>
        </p:nvSpPr>
        <p:spPr>
          <a:xfrm>
            <a:off x="10223011" y="545525"/>
            <a:ext cx="888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직사각형 111"/>
          <p:cNvSpPr/>
          <p:nvPr/>
        </p:nvSpPr>
        <p:spPr>
          <a:xfrm>
            <a:off x="283045" y="3835662"/>
            <a:ext cx="11767195" cy="285527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6111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0</TotalTime>
  <Words>590</Words>
  <Application>Microsoft Office PowerPoint</Application>
  <PresentationFormat>와이드스크린</PresentationFormat>
  <Paragraphs>141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DHC20</dc:creator>
  <cp:lastModifiedBy>CAU</cp:lastModifiedBy>
  <cp:revision>199</cp:revision>
  <dcterms:created xsi:type="dcterms:W3CDTF">2020-11-01T23:25:36Z</dcterms:created>
  <dcterms:modified xsi:type="dcterms:W3CDTF">2021-09-15T10:30:44Z</dcterms:modified>
</cp:coreProperties>
</file>